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023" userDrawn="1">
          <p15:clr>
            <a:srgbClr val="A4A3A4"/>
          </p15:clr>
        </p15:guide>
        <p15:guide id="2" pos="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2742" y="96"/>
      </p:cViewPr>
      <p:guideLst>
        <p:guide orient="horz" pos="6023"/>
        <p:guide pos="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29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4550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385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2450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7754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418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7674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8675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0463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0490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7134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6B8BA-9583-4635-9A0F-864D5EAA8125}" type="datetimeFigureOut">
              <a:rPr lang="de-DE" smtClean="0"/>
              <a:t>05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634DC-EB95-4239-8AA8-ABE075A9D5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8120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92" y="201388"/>
            <a:ext cx="6630416" cy="260637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13792" y="3104153"/>
            <a:ext cx="663041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ample pictures of kidneys with connectors. Kidneys were perfused with whole blood for 4 h. Afterwards a physician with experience in kidney transplantation graded the kidneys and grouped them into “Potentially transplantable” (a) and “Not transplantable” (b) based on macroscopic perfusion quality. The “Potentially transplantable” kidneys had a homogenous, rosy coloring whereas the ”Not transplantable” kidneys had a dark livid coloration or exhibited an insufficient perfusion marked by a marbled coloration. Scale: single lines are 1 mm apart, large squares have an edge length of 10 m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0807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7</Words>
  <Application>Microsoft Office PowerPoint</Application>
  <PresentationFormat>A4-Papier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inhauser, Carla</dc:creator>
  <cp:lastModifiedBy>Steinhauser, Carla</cp:lastModifiedBy>
  <cp:revision>4</cp:revision>
  <dcterms:created xsi:type="dcterms:W3CDTF">2023-12-05T10:07:42Z</dcterms:created>
  <dcterms:modified xsi:type="dcterms:W3CDTF">2023-12-05T10:20:30Z</dcterms:modified>
</cp:coreProperties>
</file>